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7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7"/>
    <a:srgbClr val="99FFCC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3" autoAdjust="0"/>
    <p:restoredTop sz="95139" autoAdjust="0"/>
  </p:normalViewPr>
  <p:slideViewPr>
    <p:cSldViewPr>
      <p:cViewPr varScale="1">
        <p:scale>
          <a:sx n="79" d="100"/>
          <a:sy n="79" d="100"/>
        </p:scale>
        <p:origin x="485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5" d="100"/>
        <a:sy n="125" d="100"/>
      </p:scale>
      <p:origin x="0" y="2333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421AE8-B305-4190-935A-A6C830857FE3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5630FF-F02B-4626-82E1-C46299F894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56051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ADDAC483-7313-4644-970F-0EDFC3A106FE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CEC04829-1CB9-4F51-8A07-D65AE5A98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479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9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470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747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2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2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990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466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4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704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693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7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003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793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4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80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462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4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CCB72-9C25-4AD7-B59B-5176EE691596}" type="datetimeFigureOut">
              <a:rPr lang="en-US" smtClean="0"/>
              <a:t>6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4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E3C8D-73AB-4C2D-92C3-1C454415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1129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77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1" indent="-342891" algn="l" defTabSz="914377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defTabSz="914377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421D97E-5A8A-4FD0-B67B-976FCCCF12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9698" y="304800"/>
            <a:ext cx="7824603" cy="4400339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28661109-D6A6-4B1D-B050-3A989BA63181}"/>
              </a:ext>
            </a:extLst>
          </p:cNvPr>
          <p:cNvSpPr/>
          <p:nvPr/>
        </p:nvSpPr>
        <p:spPr>
          <a:xfrm>
            <a:off x="762000" y="5029200"/>
            <a:ext cx="7824603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ea typeface="Times New Roman" panose="02020603050405020304" pitchFamily="18" charset="0"/>
              </a:rPr>
              <a:t>Additional file 2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. QTL analysis results of D2.HD-F</a:t>
            </a:r>
            <a:r>
              <a:rPr lang="en-US" sz="1600" b="1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and the combined D2.HD-N</a:t>
            </a:r>
            <a:r>
              <a:rPr lang="en-US" sz="1600" b="1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and D2.HD-F</a:t>
            </a:r>
            <a:r>
              <a:rPr lang="en-US" sz="1600" b="1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cohorts.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D2.HD-F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(16 affected, 16 unaffected) and D2.HD-N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(19 affected, 6 unaffected) were combined and run as a single population (n=57) using an F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 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scenario in R/</a:t>
            </a:r>
            <a:r>
              <a:rPr lang="en-US" sz="1600" dirty="0" err="1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qtl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. 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A.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D2.HD-F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plot 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B.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Combined plot. No significance was identified for F</a:t>
            </a:r>
            <a:r>
              <a:rPr lang="en-US" sz="1600" baseline="-250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2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rPr>
              <a:t> or the combined populations.</a:t>
            </a:r>
            <a:endParaRPr lang="en-US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907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solidFill>
          <a:schemeClr val="bg1"/>
        </a:solidFill>
      </a:spPr>
      <a:bodyPr wrap="square" lIns="0" tIns="0" rIns="0" bIns="0" rtlCol="0">
        <a:spAutoFit/>
      </a:bodyPr>
      <a:lstStyle>
        <a:defPPr algn="r">
          <a:lnSpc>
            <a:spcPts val="5700"/>
          </a:lnSpc>
          <a:defRPr sz="1400" b="1"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851</TotalTime>
  <Words>8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MS Mincho</vt:lpstr>
      <vt:lpstr>Arial</vt:lpstr>
      <vt:lpstr>Calibri</vt:lpstr>
      <vt:lpstr>Times New Roman</vt:lpstr>
      <vt:lpstr>Office Theme</vt:lpstr>
      <vt:lpstr>PowerPoint Presentation</vt:lpstr>
    </vt:vector>
  </TitlesOfParts>
  <Company>CCH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CHMC</dc:creator>
  <cp:lastModifiedBy>prop73</cp:lastModifiedBy>
  <cp:revision>330</cp:revision>
  <cp:lastPrinted>2019-04-17T14:37:59Z</cp:lastPrinted>
  <dcterms:created xsi:type="dcterms:W3CDTF">2012-04-10T18:38:20Z</dcterms:created>
  <dcterms:modified xsi:type="dcterms:W3CDTF">2019-06-10T19:30:18Z</dcterms:modified>
</cp:coreProperties>
</file>